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7E4E288-571B-4326-9347-DCD90E0BF7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F7DFB766-C7C1-4485-9CD8-EC7A682465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FABD6D7-06ED-45F0-8DF5-1A08ED1B6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8810210-9B3A-430D-94FF-82CDFFAA8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77F8FB0-0B6D-47B7-84B7-BB0B3123A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8784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1CDC0E2-DE5F-4488-BBDA-54DED11AF7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F7DBB41E-D9FB-4915-A6CA-0B49E75213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3FF1F37-FEEE-44AD-9E07-C4FA796B3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C9ADDED-5AE4-4950-8894-00CEEEF0A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8CAB0F7-22A3-4C61-96B7-B60FFAC70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8494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C9D9881B-DE89-436A-BD2C-87E8BC7408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A5D8ECEE-1C6D-4DE5-8EA3-2EE4B77D0E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8DB7A55-3B0E-47A4-B724-C4C9BC616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7714435-4EE3-41C7-828D-3513946F1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DEB168C-C9ED-417F-B26C-179E8068F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44361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BAD13CF-659B-42C4-8C58-74050B9ED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A66620E2-0A3A-4698-B097-06C7CB585F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EA6EAE3-7E24-403C-B59C-1D705A4D4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1867371-5AE4-483C-8FB6-FBB34C03F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B1B7278-9C4C-40BF-AD13-303E069EB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2440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4E158DA-0746-44A3-83ED-EED5F2CAA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4C697FB-CD10-4C2C-9D00-9981444136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9AEB0DE-5E67-4908-A3DC-1160FF195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6E3BA91-51A0-4FC2-9AC7-45DD3FF31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55F7AF9-10F3-4C0D-B77F-F73873502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9831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87C2BC5-2AA7-4514-B815-99955A47C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1DE527E-7B07-4A86-899F-C761A565D2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670673E0-68C2-44B8-B6FC-F2B7577F8F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6CFE31D8-87B7-4DD5-B066-9C122B009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3EF1F61-EC2B-477C-872C-37DD87AFD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25762EC4-2A40-4CF2-8A13-CB5122A92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6068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95D6CCD-6748-45A4-A100-BE6A0E939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74CD63C-3957-45DD-91D3-8B43B5DF4A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CF0179DA-52AC-4044-AFDD-3EDCA1B07A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62949F8D-A6F3-40B0-A1FF-E185DE1003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4B4A6C2A-F006-49E0-8FFA-5530D56CDB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9B4FF63E-58D2-4058-B7B8-E20FCB974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009B5BE7-4A67-4FC3-A494-D61481AE1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C5FDF3CB-7AB2-40F3-BBE8-E24D5240D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734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8488577-0B90-4740-94DE-74FA0EA62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B0C4E80F-FCC2-425A-B3F5-3541BE393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2300E01-EE40-4633-9D04-AC9BA2E09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F7D7573B-0ADA-4111-9D94-F1518DCF1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2456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4E65D9C5-17C5-4A23-9DF9-A14B3A08B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52A34594-409F-4B02-975B-DEAF4E00A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5A2CDCB6-2F19-405A-9288-D31D03694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94182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F5AA66C-5636-4D29-87C4-B171C1EAA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8A4DF3DA-F340-49F1-858A-294D68AC81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CCA384C-14D9-4D33-88AF-FA2C95535B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0677CAB2-EAAF-4FD2-A1EE-14B06B7D9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DF5F7E5-7378-46AD-A543-BE5F4FEE6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27F02F75-700E-44A0-A237-D39388C9E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11799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10129CC-EE32-4C76-817A-CA4E13413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81D5A948-FCEF-4AC5-9EAC-8F1CC7FF85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813DE47-7751-4536-9796-B03154865C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13FB238-EFE1-4C40-8AAA-5EA008CC7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DF35F5F-7845-4C70-85F9-DCB6F210F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6FF6FB86-7A8C-4A7E-A1E2-4222F90B9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102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5CAAF9B4-D52C-4357-AD61-7AE26D56A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6AAE876-0D22-424C-9472-9B849134E4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7E5B9FD-20D0-4D10-ABBC-1B31F6523D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5724A-5EE1-4DAF-97DB-88838E898A01}" type="datetimeFigureOut">
              <a:rPr lang="zh-TW" altLang="en-US" smtClean="0"/>
              <a:t>2022/1/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0D76893-3540-44CE-A0E8-FC7754CD29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7B56680-E328-476E-BD3A-B7E98AC4DD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045DA-3005-46A8-ACF5-0E654B05D6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4846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7766"/>
            <a:ext cx="12193057" cy="4462659"/>
          </a:xfrm>
          <a:prstGeom prst="rect">
            <a:avLst/>
          </a:prstGeom>
          <a:solidFill>
            <a:schemeClr val="accent1">
              <a:lumMod val="40000"/>
              <a:lumOff val="60000"/>
              <a:alpha val="68000"/>
            </a:schemeClr>
          </a:solidFill>
        </p:spPr>
      </p:pic>
      <p:sp>
        <p:nvSpPr>
          <p:cNvPr id="5" name="矩形 4"/>
          <p:cNvSpPr/>
          <p:nvPr/>
        </p:nvSpPr>
        <p:spPr>
          <a:xfrm>
            <a:off x="788277" y="-44265"/>
            <a:ext cx="10342178" cy="14784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TW" sz="3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ep learning-based pain classifier based on the facial expression in critically ill patients</a:t>
            </a:r>
            <a:endParaRPr lang="zh-TW" altLang="en-US" sz="32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619227" y="1696768"/>
            <a:ext cx="4382814" cy="446265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-50790" y="4590110"/>
            <a:ext cx="376197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Critically ill patients </a:t>
            </a:r>
          </a:p>
          <a:p>
            <a:pPr algn="ctr"/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with pain score </a:t>
            </a:r>
          </a:p>
          <a:p>
            <a:pPr algn="ctr"/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0,1, and 2</a:t>
            </a:r>
            <a:endParaRPr lang="zh-TW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3725023" y="4524813"/>
            <a:ext cx="40932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 3 CNN models and BiLSTM to establish pain classifiers </a:t>
            </a:r>
            <a:endParaRPr lang="zh-TW" altLang="en-US" sz="2400" b="1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7979982" y="4431816"/>
            <a:ext cx="409327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Accuracy</a:t>
            </a:r>
          </a:p>
          <a:p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I. To classify 0 vs 1/2: 0.81</a:t>
            </a:r>
          </a:p>
          <a:p>
            <a:r>
              <a:rPr lang="en-US" altLang="zh-TW" sz="2400" b="1" dirty="0">
                <a:latin typeface="Arial" panose="020B0604020202020204" pitchFamily="34" charset="0"/>
                <a:cs typeface="Arial" panose="020B0604020202020204" pitchFamily="34" charset="0"/>
              </a:rPr>
              <a:t>II. To classify 0 vs 2: 0.88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群組 15">
            <a:extLst>
              <a:ext uri="{FF2B5EF4-FFF2-40B4-BE49-F238E27FC236}">
                <a16:creationId xmlns:a16="http://schemas.microsoft.com/office/drawing/2014/main" id="{8AFD605A-C3ED-4F5D-95FF-EE7E72422C3F}"/>
              </a:ext>
            </a:extLst>
          </p:cNvPr>
          <p:cNvGrpSpPr/>
          <p:nvPr/>
        </p:nvGrpSpPr>
        <p:grpSpPr>
          <a:xfrm>
            <a:off x="202387" y="1810189"/>
            <a:ext cx="3178632" cy="2590351"/>
            <a:chOff x="119588" y="2146978"/>
            <a:chExt cx="3091618" cy="2520119"/>
          </a:xfrm>
        </p:grpSpPr>
        <p:pic>
          <p:nvPicPr>
            <p:cNvPr id="2" name="圖片 1">
              <a:extLst>
                <a:ext uri="{FF2B5EF4-FFF2-40B4-BE49-F238E27FC236}">
                  <a16:creationId xmlns:a16="http://schemas.microsoft.com/office/drawing/2014/main" id="{305783E6-2C26-4605-9A89-E92D3235C2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6369" y="2952760"/>
              <a:ext cx="3079270" cy="1425442"/>
            </a:xfrm>
            <a:prstGeom prst="rect">
              <a:avLst/>
            </a:prstGeom>
          </p:spPr>
        </p:pic>
        <p:pic>
          <p:nvPicPr>
            <p:cNvPr id="6" name="圖片 5">
              <a:extLst>
                <a:ext uri="{FF2B5EF4-FFF2-40B4-BE49-F238E27FC236}">
                  <a16:creationId xmlns:a16="http://schemas.microsoft.com/office/drawing/2014/main" id="{8FFEEFFE-EA9C-4FCB-99C0-7B48ECC835E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9588" y="2148538"/>
              <a:ext cx="1122189" cy="802789"/>
            </a:xfrm>
            <a:prstGeom prst="rect">
              <a:avLst/>
            </a:prstGeom>
            <a:solidFill>
              <a:schemeClr val="bg1"/>
            </a:solidFill>
          </p:spPr>
        </p:pic>
        <p:pic>
          <p:nvPicPr>
            <p:cNvPr id="14" name="圖片 13">
              <a:extLst>
                <a:ext uri="{FF2B5EF4-FFF2-40B4-BE49-F238E27FC236}">
                  <a16:creationId xmlns:a16="http://schemas.microsoft.com/office/drawing/2014/main" id="{1BD996FD-DCD2-4FC9-B0B0-97B7EC4C647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71575" y="2146978"/>
              <a:ext cx="2039631" cy="829588"/>
            </a:xfrm>
            <a:prstGeom prst="rect">
              <a:avLst/>
            </a:prstGeom>
            <a:solidFill>
              <a:schemeClr val="bg1"/>
            </a:solidFill>
          </p:spPr>
        </p:pic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4BA83ABF-7EA5-4B14-99A2-E3A2E4ECBBC1}"/>
                </a:ext>
              </a:extLst>
            </p:cNvPr>
            <p:cNvSpPr txBox="1"/>
            <p:nvPr/>
          </p:nvSpPr>
          <p:spPr>
            <a:xfrm>
              <a:off x="126367" y="4337722"/>
              <a:ext cx="3079271" cy="3293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in score</a:t>
              </a:r>
              <a:endParaRPr lang="zh-TW" altLang="en-US" dirty="0"/>
            </a:p>
          </p:txBody>
        </p:sp>
      </p:grpSp>
      <p:sp>
        <p:nvSpPr>
          <p:cNvPr id="36" name="文字方塊 2">
            <a:extLst>
              <a:ext uri="{FF2B5EF4-FFF2-40B4-BE49-F238E27FC236}">
                <a16:creationId xmlns:a16="http://schemas.microsoft.com/office/drawing/2014/main" id="{492E381A-3984-43BC-8B8C-241BEE2363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2930" y="1922701"/>
            <a:ext cx="1579611" cy="404073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Resnet34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2">
            <a:extLst>
              <a:ext uri="{FF2B5EF4-FFF2-40B4-BE49-F238E27FC236}">
                <a16:creationId xmlns:a16="http://schemas.microsoft.com/office/drawing/2014/main" id="{D60BF1D8-6944-4B3E-A15A-73CD5FB369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2931" y="2582448"/>
            <a:ext cx="1579610" cy="387461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VGG16 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8" name="文字方塊 2">
            <a:extLst>
              <a:ext uri="{FF2B5EF4-FFF2-40B4-BE49-F238E27FC236}">
                <a16:creationId xmlns:a16="http://schemas.microsoft.com/office/drawing/2014/main" id="{1F5E025C-8678-47FC-8695-953E680AA2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18231" y="2541228"/>
            <a:ext cx="1383810" cy="469900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iLSTM</a:t>
            </a:r>
            <a:endParaRPr lang="zh-TW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2">
            <a:extLst>
              <a:ext uri="{FF2B5EF4-FFF2-40B4-BE49-F238E27FC236}">
                <a16:creationId xmlns:a16="http://schemas.microsoft.com/office/drawing/2014/main" id="{232983C5-7ED8-4C68-8893-3A979FB2E1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2243" y="3194280"/>
            <a:ext cx="1646999" cy="425220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nceptionV1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pSp>
        <p:nvGrpSpPr>
          <p:cNvPr id="22" name="群組 21">
            <a:extLst>
              <a:ext uri="{FF2B5EF4-FFF2-40B4-BE49-F238E27FC236}">
                <a16:creationId xmlns:a16="http://schemas.microsoft.com/office/drawing/2014/main" id="{80532417-7258-4FCF-8E0E-6F753A372309}"/>
              </a:ext>
            </a:extLst>
          </p:cNvPr>
          <p:cNvGrpSpPr/>
          <p:nvPr/>
        </p:nvGrpSpPr>
        <p:grpSpPr>
          <a:xfrm>
            <a:off x="3720970" y="1892747"/>
            <a:ext cx="1121234" cy="1701643"/>
            <a:chOff x="3837549" y="2261804"/>
            <a:chExt cx="1121234" cy="1701643"/>
          </a:xfrm>
        </p:grpSpPr>
        <p:pic>
          <p:nvPicPr>
            <p:cNvPr id="7" name="圖片 6">
              <a:extLst>
                <a:ext uri="{FF2B5EF4-FFF2-40B4-BE49-F238E27FC236}">
                  <a16:creationId xmlns:a16="http://schemas.microsoft.com/office/drawing/2014/main" id="{7CAE2163-8206-4B12-A8F8-EB2EA4AB75B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37549" y="2261804"/>
              <a:ext cx="1121234" cy="1301533"/>
            </a:xfrm>
            <a:prstGeom prst="rect">
              <a:avLst/>
            </a:prstGeom>
          </p:spPr>
        </p:pic>
        <p:sp>
          <p:nvSpPr>
            <p:cNvPr id="40" name="文字方塊 39">
              <a:extLst>
                <a:ext uri="{FF2B5EF4-FFF2-40B4-BE49-F238E27FC236}">
                  <a16:creationId xmlns:a16="http://schemas.microsoft.com/office/drawing/2014/main" id="{3658EA87-53F1-499A-8F08-136450554362}"/>
                </a:ext>
              </a:extLst>
            </p:cNvPr>
            <p:cNvSpPr txBox="1"/>
            <p:nvPr/>
          </p:nvSpPr>
          <p:spPr>
            <a:xfrm>
              <a:off x="3837549" y="3563337"/>
              <a:ext cx="112123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rop</a:t>
              </a:r>
              <a:endParaRPr lang="zh-TW" altLang="en-US" dirty="0"/>
            </a:p>
          </p:txBody>
        </p:sp>
      </p:grpSp>
      <p:pic>
        <p:nvPicPr>
          <p:cNvPr id="29" name="圖片 28">
            <a:extLst>
              <a:ext uri="{FF2B5EF4-FFF2-40B4-BE49-F238E27FC236}">
                <a16:creationId xmlns:a16="http://schemas.microsoft.com/office/drawing/2014/main" id="{EC1B4827-AA76-4A2A-9682-72B1282EB3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17939" y="1907252"/>
            <a:ext cx="681831" cy="1030190"/>
          </a:xfrm>
          <a:prstGeom prst="rect">
            <a:avLst/>
          </a:prstGeom>
        </p:spPr>
      </p:pic>
      <p:pic>
        <p:nvPicPr>
          <p:cNvPr id="41" name="圖片 40">
            <a:extLst>
              <a:ext uri="{FF2B5EF4-FFF2-40B4-BE49-F238E27FC236}">
                <a16:creationId xmlns:a16="http://schemas.microsoft.com/office/drawing/2014/main" id="{66D84FC2-E885-4ED1-830B-40D21C7639B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37193" y="1855673"/>
            <a:ext cx="1608524" cy="1168427"/>
          </a:xfrm>
          <a:prstGeom prst="rect">
            <a:avLst/>
          </a:prstGeom>
        </p:spPr>
      </p:pic>
      <p:pic>
        <p:nvPicPr>
          <p:cNvPr id="42" name="圖片 41">
            <a:extLst>
              <a:ext uri="{FF2B5EF4-FFF2-40B4-BE49-F238E27FC236}">
                <a16:creationId xmlns:a16="http://schemas.microsoft.com/office/drawing/2014/main" id="{930A33A2-E8BA-4BDF-BB02-9E7C6E1A99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89539" y="3249759"/>
            <a:ext cx="653474" cy="987346"/>
          </a:xfrm>
          <a:prstGeom prst="rect">
            <a:avLst/>
          </a:prstGeom>
        </p:spPr>
      </p:pic>
      <p:pic>
        <p:nvPicPr>
          <p:cNvPr id="43" name="圖片 42">
            <a:extLst>
              <a:ext uri="{FF2B5EF4-FFF2-40B4-BE49-F238E27FC236}">
                <a16:creationId xmlns:a16="http://schemas.microsoft.com/office/drawing/2014/main" id="{ACD2E7D7-7439-4E67-B800-A5581382FC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202299" y="3205980"/>
            <a:ext cx="759209" cy="999722"/>
          </a:xfrm>
          <a:prstGeom prst="rect">
            <a:avLst/>
          </a:prstGeom>
        </p:spPr>
      </p:pic>
      <p:sp>
        <p:nvSpPr>
          <p:cNvPr id="44" name="箭號: 向右 43">
            <a:extLst>
              <a:ext uri="{FF2B5EF4-FFF2-40B4-BE49-F238E27FC236}">
                <a16:creationId xmlns:a16="http://schemas.microsoft.com/office/drawing/2014/main" id="{E10CAFA4-94D6-41D5-98E3-E5CBC02C326A}"/>
              </a:ext>
            </a:extLst>
          </p:cNvPr>
          <p:cNvSpPr/>
          <p:nvPr/>
        </p:nvSpPr>
        <p:spPr>
          <a:xfrm>
            <a:off x="9099770" y="2248223"/>
            <a:ext cx="558580" cy="274163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5" name="箭號: 向右 44">
            <a:extLst>
              <a:ext uri="{FF2B5EF4-FFF2-40B4-BE49-F238E27FC236}">
                <a16:creationId xmlns:a16="http://schemas.microsoft.com/office/drawing/2014/main" id="{565590C3-63B0-4861-8F8D-106F7C669D3C}"/>
              </a:ext>
            </a:extLst>
          </p:cNvPr>
          <p:cNvSpPr/>
          <p:nvPr/>
        </p:nvSpPr>
        <p:spPr>
          <a:xfrm>
            <a:off x="9143012" y="3581793"/>
            <a:ext cx="982063" cy="274163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6980E990-4B5E-451B-B949-59C007CF15C4}"/>
              </a:ext>
            </a:extLst>
          </p:cNvPr>
          <p:cNvSpPr/>
          <p:nvPr/>
        </p:nvSpPr>
        <p:spPr>
          <a:xfrm>
            <a:off x="8659823" y="2623852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TW" altLang="en-US" dirty="0"/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EB5025FD-E2CA-4F03-9654-1355123EA8A1}"/>
              </a:ext>
            </a:extLst>
          </p:cNvPr>
          <p:cNvSpPr/>
          <p:nvPr/>
        </p:nvSpPr>
        <p:spPr>
          <a:xfrm>
            <a:off x="8748421" y="3935678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TW" altLang="en-US" dirty="0"/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74302BA4-CD45-4A06-B96E-CA3A6DBC15AA}"/>
              </a:ext>
            </a:extLst>
          </p:cNvPr>
          <p:cNvSpPr/>
          <p:nvPr/>
        </p:nvSpPr>
        <p:spPr>
          <a:xfrm>
            <a:off x="9928578" y="2709842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dirty="0"/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170743FA-7815-4A1A-A1AF-214BD63D7B25}"/>
              </a:ext>
            </a:extLst>
          </p:cNvPr>
          <p:cNvSpPr/>
          <p:nvPr/>
        </p:nvSpPr>
        <p:spPr>
          <a:xfrm>
            <a:off x="10805055" y="2677122"/>
            <a:ext cx="31290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dirty="0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F939C4A0-126C-4D7C-88EB-AF91314FE182}"/>
              </a:ext>
            </a:extLst>
          </p:cNvPr>
          <p:cNvSpPr/>
          <p:nvPr/>
        </p:nvSpPr>
        <p:spPr>
          <a:xfrm>
            <a:off x="10492149" y="3913536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dirty="0"/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1A3FDCDC-3736-4436-986A-ABBEABBD85BB}"/>
              </a:ext>
            </a:extLst>
          </p:cNvPr>
          <p:cNvSpPr/>
          <p:nvPr/>
        </p:nvSpPr>
        <p:spPr>
          <a:xfrm>
            <a:off x="487497" y="3794722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TW" altLang="en-US" dirty="0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75EFCAB5-2790-4B07-9878-94F98FFB01E6}"/>
              </a:ext>
            </a:extLst>
          </p:cNvPr>
          <p:cNvSpPr/>
          <p:nvPr/>
        </p:nvSpPr>
        <p:spPr>
          <a:xfrm>
            <a:off x="1653161" y="3776624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dirty="0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E70E2219-1F69-456D-81CB-D95B17B0B614}"/>
              </a:ext>
            </a:extLst>
          </p:cNvPr>
          <p:cNvSpPr/>
          <p:nvPr/>
        </p:nvSpPr>
        <p:spPr>
          <a:xfrm>
            <a:off x="2788206" y="3749577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5D293C7-565E-4D48-9BF4-925E039A25DB}"/>
              </a:ext>
            </a:extLst>
          </p:cNvPr>
          <p:cNvSpPr txBox="1"/>
          <p:nvPr/>
        </p:nvSpPr>
        <p:spPr>
          <a:xfrm flipH="1">
            <a:off x="3653432" y="3752093"/>
            <a:ext cx="4250975" cy="338554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Preprocessing</a:t>
            </a:r>
            <a:r>
              <a:rPr lang="en-US" altLang="zh-TW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6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</a:t>
            </a:r>
            <a:r>
              <a:rPr lang="en-US" altLang="zh-TW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Train (60%) Validate (20%) Test (20%)</a:t>
            </a:r>
            <a:endParaRPr lang="zh-TW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699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81</Words>
  <Application>Microsoft Office PowerPoint</Application>
  <PresentationFormat>寬螢幕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Times New Roman</vt:lpstr>
      <vt:lpstr>Wingdings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文震 趙</dc:creator>
  <cp:lastModifiedBy>文震 趙</cp:lastModifiedBy>
  <cp:revision>21</cp:revision>
  <dcterms:created xsi:type="dcterms:W3CDTF">2021-07-17T13:52:57Z</dcterms:created>
  <dcterms:modified xsi:type="dcterms:W3CDTF">2022-01-08T13:01:40Z</dcterms:modified>
</cp:coreProperties>
</file>